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4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00" userDrawn="1">
          <p15:clr>
            <a:srgbClr val="A4A3A4"/>
          </p15:clr>
        </p15:guide>
        <p15:guide id="2" pos="7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300"/>
    <a:srgbClr val="C09100"/>
    <a:srgbClr val="2973B9"/>
    <a:srgbClr val="C89A00"/>
    <a:srgbClr val="F14900"/>
    <a:srgbClr val="E14403"/>
    <a:srgbClr val="2B81C2"/>
    <a:srgbClr val="F9DD00"/>
    <a:srgbClr val="FA5A06"/>
    <a:srgbClr val="43C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02"/>
    <p:restoredTop sz="88689"/>
  </p:normalViewPr>
  <p:slideViewPr>
    <p:cSldViewPr snapToGrid="0" snapToObjects="1" showGuides="1">
      <p:cViewPr>
        <p:scale>
          <a:sx n="105" d="100"/>
          <a:sy n="105" d="100"/>
        </p:scale>
        <p:origin x="800" y="-360"/>
      </p:cViewPr>
      <p:guideLst>
        <p:guide orient="horz" pos="5400"/>
        <p:guide pos="744"/>
      </p:guideLst>
    </p:cSldViewPr>
  </p:slideViewPr>
  <p:notesTextViewPr>
    <p:cViewPr>
      <p:scale>
        <a:sx n="85" d="100"/>
        <a:sy n="85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F69FB2-9E77-AE40-9402-CD320D8F420A}" type="datetimeFigureOut">
              <a:rPr lang="en-US" smtClean="0"/>
              <a:t>12/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53D5EE-7DDF-084A-A8E6-F948496FBD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7454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53D5EE-7DDF-084A-A8E6-F948496FBDE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331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03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721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246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070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458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73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945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370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812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44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086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237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91F7417-A5AC-4C44-A4CD-650B169911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2966290"/>
              </p:ext>
            </p:extLst>
          </p:nvPr>
        </p:nvGraphicFramePr>
        <p:xfrm>
          <a:off x="36474" y="1246033"/>
          <a:ext cx="6814279" cy="4407408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5544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6604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4640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033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8569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8569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8211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46604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538366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53033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3951985300"/>
                    </a:ext>
                  </a:extLst>
                </a:gridCol>
                <a:gridCol w="461962">
                  <a:extLst>
                    <a:ext uri="{9D8B030D-6E8A-4147-A177-3AD203B41FA5}">
                      <a16:colId xmlns:a16="http://schemas.microsoft.com/office/drawing/2014/main" val="1851482063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algn="ctr" fontAlgn="t"/>
                      <a:r>
                        <a:rPr lang="sk-SK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sk-SK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</a:t>
                      </a:r>
                    </a:p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</a:p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WT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WT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4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</a:t>
                      </a:r>
                    </a:p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af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</a:t>
                      </a:r>
                    </a:p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af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</a:t>
                      </a:r>
                    </a:p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35329634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WT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WT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8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10896"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 leaf rep1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Georgia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98926931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7D5A1BB2-4A85-9F48-8330-73D7FE74FADA}"/>
              </a:ext>
            </a:extLst>
          </p:cNvPr>
          <p:cNvSpPr/>
          <p:nvPr/>
        </p:nvSpPr>
        <p:spPr>
          <a:xfrm>
            <a:off x="740131" y="845923"/>
            <a:ext cx="540696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earson's product moment correlation coefficients (r) between pairs of samples used in this study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43C2811-8FA7-1147-8C0D-81DDBE448717}"/>
              </a:ext>
            </a:extLst>
          </p:cNvPr>
          <p:cNvSpPr/>
          <p:nvPr/>
        </p:nvSpPr>
        <p:spPr>
          <a:xfrm>
            <a:off x="5317995" y="123153"/>
            <a:ext cx="158248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2100058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866</TotalTime>
  <Words>194</Words>
  <Application>Microsoft Macintosh PowerPoint</Application>
  <PresentationFormat>A4 Paper (210x297 mm)</PresentationFormat>
  <Paragraphs>1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 Jeff</dc:creator>
  <cp:lastModifiedBy>Huang Jeff</cp:lastModifiedBy>
  <cp:revision>208</cp:revision>
  <cp:lastPrinted>2020-11-24T21:15:37Z</cp:lastPrinted>
  <dcterms:created xsi:type="dcterms:W3CDTF">2018-06-06T18:52:07Z</dcterms:created>
  <dcterms:modified xsi:type="dcterms:W3CDTF">2020-12-03T19:02:30Z</dcterms:modified>
</cp:coreProperties>
</file>